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25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lipid 18s'!$I$26</c:f>
              <c:strCache>
                <c:ptCount val="1"/>
                <c:pt idx="0">
                  <c:v>Relative transcript abundance (FC)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strRef>
              <c:f>'lipid 18s'!$H$27:$H$31</c:f>
              <c:strCache>
                <c:ptCount val="5"/>
                <c:pt idx="0">
                  <c:v>Eggs</c:v>
                </c:pt>
                <c:pt idx="1">
                  <c:v>J2 Hatched</c:v>
                </c:pt>
                <c:pt idx="2">
                  <c:v>J2 12h AI</c:v>
                </c:pt>
                <c:pt idx="3">
                  <c:v>J3/4</c:v>
                </c:pt>
                <c:pt idx="4">
                  <c:v>Females</c:v>
                </c:pt>
              </c:strCache>
            </c:strRef>
          </c:cat>
          <c:val>
            <c:numRef>
              <c:f>'lipid 18s'!$I$27:$I$31</c:f>
              <c:numCache>
                <c:formatCode>General</c:formatCode>
                <c:ptCount val="5"/>
                <c:pt idx="0">
                  <c:v>1</c:v>
                </c:pt>
                <c:pt idx="1">
                  <c:v>4.6964415211672057E-2</c:v>
                </c:pt>
                <c:pt idx="2">
                  <c:v>0</c:v>
                </c:pt>
                <c:pt idx="3">
                  <c:v>73.057659068047556</c:v>
                </c:pt>
                <c:pt idx="4">
                  <c:v>694.047761146451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132-478E-851E-B314037DB8A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18642024"/>
        <c:axId val="418640848"/>
      </c:barChart>
      <c:catAx>
        <c:axId val="4186420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>
                    <a:solidFill>
                      <a:schemeClr val="tx1"/>
                    </a:solidFill>
                  </a:rPr>
                  <a:t>RKN</a:t>
                </a:r>
                <a:r>
                  <a:rPr lang="en-US" sz="1400" b="1" baseline="0">
                    <a:solidFill>
                      <a:schemeClr val="tx1"/>
                    </a:solidFill>
                  </a:rPr>
                  <a:t> development stages</a:t>
                </a:r>
                <a:endParaRPr lang="en-US" sz="1400" b="1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418640848"/>
        <c:crosses val="autoZero"/>
        <c:auto val="1"/>
        <c:lblAlgn val="ctr"/>
        <c:lblOffset val="100"/>
        <c:noMultiLvlLbl val="0"/>
      </c:catAx>
      <c:valAx>
        <c:axId val="418640848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i="0" baseline="0">
                    <a:solidFill>
                      <a:schemeClr val="tx1"/>
                    </a:solidFill>
                    <a:effectLst/>
                  </a:rPr>
                  <a:t>Relative transcript abundance (FC)</a:t>
                </a:r>
                <a:endParaRPr lang="he-IL" sz="1200" b="1">
                  <a:solidFill>
                    <a:schemeClr val="tx1"/>
                  </a:solidFill>
                  <a:effectLst/>
                </a:endParaRPr>
              </a:p>
            </c:rich>
          </c:tx>
          <c:layout>
            <c:manualLayout>
              <c:xMode val="edge"/>
              <c:yMode val="edge"/>
              <c:x val="3.0555555555555555E-2"/>
              <c:y val="0.1580785214348206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4186420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/>
      </a:pPr>
      <a:endParaRPr lang="he-IL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lt10 18S'!$J$31</c:f>
              <c:strCache>
                <c:ptCount val="1"/>
                <c:pt idx="0">
                  <c:v>Relative transcript abundance (FC)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strRef>
              <c:f>'mlt10 18S'!$I$32:$I$36</c:f>
              <c:strCache>
                <c:ptCount val="5"/>
                <c:pt idx="0">
                  <c:v>eggs</c:v>
                </c:pt>
                <c:pt idx="1">
                  <c:v>J2 Hatched</c:v>
                </c:pt>
                <c:pt idx="2">
                  <c:v>J2 12h AI</c:v>
                </c:pt>
                <c:pt idx="3">
                  <c:v>J3/4</c:v>
                </c:pt>
                <c:pt idx="4">
                  <c:v>Females</c:v>
                </c:pt>
              </c:strCache>
            </c:strRef>
          </c:cat>
          <c:val>
            <c:numRef>
              <c:f>'mlt10 18S'!$J$32:$J$36</c:f>
              <c:numCache>
                <c:formatCode>General</c:formatCode>
                <c:ptCount val="5"/>
                <c:pt idx="0">
                  <c:v>1</c:v>
                </c:pt>
                <c:pt idx="1">
                  <c:v>0.54494100000000001</c:v>
                </c:pt>
                <c:pt idx="2">
                  <c:v>0</c:v>
                </c:pt>
                <c:pt idx="3">
                  <c:v>7.0254799999999999</c:v>
                </c:pt>
                <c:pt idx="4">
                  <c:v>0.901356000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216-4FEA-A9A8-BE8E3F2659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7359064"/>
        <c:axId val="537359848"/>
      </c:barChart>
      <c:catAx>
        <c:axId val="5373590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chemeClr val="tx1"/>
                    </a:solidFill>
                  </a:rPr>
                  <a:t>RKN</a:t>
                </a:r>
                <a:r>
                  <a:rPr lang="en-US" sz="1200" b="1" baseline="0">
                    <a:solidFill>
                      <a:schemeClr val="tx1"/>
                    </a:solidFill>
                  </a:rPr>
                  <a:t> development stages</a:t>
                </a:r>
                <a:endParaRPr lang="en-US" sz="1200" b="1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537359848"/>
        <c:crosses val="autoZero"/>
        <c:auto val="1"/>
        <c:lblAlgn val="ctr"/>
        <c:lblOffset val="100"/>
        <c:noMultiLvlLbl val="0"/>
      </c:catAx>
      <c:valAx>
        <c:axId val="537359848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i="0" baseline="0">
                    <a:solidFill>
                      <a:schemeClr val="tx1"/>
                    </a:solidFill>
                    <a:effectLst/>
                  </a:rPr>
                  <a:t>Relative transcript abundance (FC)</a:t>
                </a:r>
                <a:endParaRPr lang="he-IL" sz="1200" b="1">
                  <a:solidFill>
                    <a:schemeClr val="tx1"/>
                  </a:solidFill>
                  <a:effectLst/>
                </a:endParaRPr>
              </a:p>
            </c:rich>
          </c:tx>
          <c:layout>
            <c:manualLayout>
              <c:xMode val="edge"/>
              <c:yMode val="edge"/>
              <c:x val="3.0555555555555555E-2"/>
              <c:y val="0.1580785214348206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5373590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/>
      </a:pPr>
      <a:endParaRPr lang="he-I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5ADD-BF5E-4FAA-9F5F-E973CE48D9D4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8FA77-8017-4BF9-AC9E-ABCE7E400D7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80930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5ADD-BF5E-4FAA-9F5F-E973CE48D9D4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8FA77-8017-4BF9-AC9E-ABCE7E400D7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522050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5ADD-BF5E-4FAA-9F5F-E973CE48D9D4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8FA77-8017-4BF9-AC9E-ABCE7E400D7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029190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5ADD-BF5E-4FAA-9F5F-E973CE48D9D4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8FA77-8017-4BF9-AC9E-ABCE7E400D7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103009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5ADD-BF5E-4FAA-9F5F-E973CE48D9D4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8FA77-8017-4BF9-AC9E-ABCE7E400D7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822380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5ADD-BF5E-4FAA-9F5F-E973CE48D9D4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8FA77-8017-4BF9-AC9E-ABCE7E400D7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27441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5ADD-BF5E-4FAA-9F5F-E973CE48D9D4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8FA77-8017-4BF9-AC9E-ABCE7E400D7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90987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5ADD-BF5E-4FAA-9F5F-E973CE48D9D4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8FA77-8017-4BF9-AC9E-ABCE7E400D7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703122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5ADD-BF5E-4FAA-9F5F-E973CE48D9D4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8FA77-8017-4BF9-AC9E-ABCE7E400D7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59022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5ADD-BF5E-4FAA-9F5F-E973CE48D9D4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8FA77-8017-4BF9-AC9E-ABCE7E400D7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300122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1D5ADD-BF5E-4FAA-9F5F-E973CE48D9D4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8FA77-8017-4BF9-AC9E-ABCE7E400D7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13748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1D5ADD-BF5E-4FAA-9F5F-E973CE48D9D4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A8FA77-8017-4BF9-AC9E-ABCE7E400D7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288202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90697" y="665102"/>
            <a:ext cx="11330249" cy="4310892"/>
            <a:chOff x="390697" y="665102"/>
            <a:chExt cx="11330249" cy="4310892"/>
          </a:xfrm>
        </p:grpSpPr>
        <p:sp>
          <p:nvSpPr>
            <p:cNvPr id="4" name="TextBox 3"/>
            <p:cNvSpPr txBox="1"/>
            <p:nvPr/>
          </p:nvSpPr>
          <p:spPr>
            <a:xfrm>
              <a:off x="1471964" y="730279"/>
              <a:ext cx="3633335" cy="369332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dirty="0" smtClean="0"/>
                <a:t>Triacylglycerol lipase</a:t>
              </a:r>
              <a:endParaRPr lang="he-IL" dirty="0"/>
            </a:p>
          </p:txBody>
        </p:sp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05147185"/>
                </p:ext>
              </p:extLst>
            </p:nvPr>
          </p:nvGraphicFramePr>
          <p:xfrm>
            <a:off x="390698" y="1099611"/>
            <a:ext cx="5641146" cy="387638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7" name="TextBox 6"/>
            <p:cNvSpPr txBox="1"/>
            <p:nvPr/>
          </p:nvSpPr>
          <p:spPr>
            <a:xfrm>
              <a:off x="8670175" y="665102"/>
              <a:ext cx="1407023" cy="369332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dirty="0" smtClean="0"/>
                <a:t>MLT-10 gene </a:t>
              </a:r>
              <a:endParaRPr lang="he-IL" dirty="0"/>
            </a:p>
          </p:txBody>
        </p:sp>
        <p:graphicFrame>
          <p:nvGraphicFramePr>
            <p:cNvPr id="8" name="Chart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21463113"/>
                </p:ext>
              </p:extLst>
            </p:nvPr>
          </p:nvGraphicFramePr>
          <p:xfrm>
            <a:off x="6186566" y="1099611"/>
            <a:ext cx="5534380" cy="387638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" name="TextBox 1"/>
            <p:cNvSpPr txBox="1"/>
            <p:nvPr/>
          </p:nvSpPr>
          <p:spPr>
            <a:xfrm>
              <a:off x="390697" y="665102"/>
              <a:ext cx="498764" cy="369332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dirty="0" smtClean="0"/>
                <a:t>A</a:t>
              </a:r>
              <a:endParaRPr lang="he-IL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186565" y="665102"/>
              <a:ext cx="498764" cy="369332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dirty="0" smtClean="0"/>
                <a:t>B</a:t>
              </a:r>
              <a:endParaRPr lang="he-IL" dirty="0"/>
            </a:p>
          </p:txBody>
        </p:sp>
      </p:grpSp>
    </p:spTree>
    <p:extLst>
      <p:ext uri="{BB962C8B-B14F-4D97-AF65-F5344CB8AC3E}">
        <p14:creationId xmlns:p14="http://schemas.microsoft.com/office/powerpoint/2010/main" val="31227145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81643" y="837840"/>
            <a:ext cx="10166465" cy="50783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4.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riacyglycerol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lipase and MLT-10-like gene-expression levels during different stages of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. </a:t>
            </a:r>
            <a:r>
              <a:rPr lang="en-US" i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javanica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development through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qRT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PCR. cDNA was generated from nematode RNA isolated at different time points: eggs, pre-parasitic hatched J2, J2 (12 h AI), J3–J4 and females. The expression level of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riacylglycerol lipase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increased during the J3–J4 and female sedentary stages of nematode development, reaching its maximum in the female stage, while expression of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LT-10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like peaked at the J3/4 stage. Each reaction was performed in triplicate and the results are presented as the mean relative expression and standard error of two independent biological replicates. Different letters above the bars denote a significant difference (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≤ 0.05, analysis of variance) between samples as analyzed by Tukey–Kramer multiple comparison test. The experiment was repeated three times and similar results were obtained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33703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73</Words>
  <Application>Microsoft Office PowerPoint</Application>
  <PresentationFormat>Widescreen</PresentationFormat>
  <Paragraphs>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Volcan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gal Brown Miyara</dc:creator>
  <cp:lastModifiedBy>Sigal Brown Miyara</cp:lastModifiedBy>
  <cp:revision>4</cp:revision>
  <dcterms:created xsi:type="dcterms:W3CDTF">2020-09-24T09:02:04Z</dcterms:created>
  <dcterms:modified xsi:type="dcterms:W3CDTF">2020-12-11T21:01:02Z</dcterms:modified>
</cp:coreProperties>
</file>